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6" r:id="rId1"/>
  </p:sldMasterIdLst>
  <p:notesMasterIdLst>
    <p:notesMasterId r:id="rId3"/>
  </p:notesMasterIdLst>
  <p:sldIdLst>
    <p:sldId id="266" r:id="rId2"/>
  </p:sldIdLst>
  <p:sldSz cx="15316200" cy="9067800"/>
  <p:notesSz cx="15316200" cy="90678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201" autoAdjust="0"/>
    <p:restoredTop sz="94660"/>
  </p:normalViewPr>
  <p:slideViewPr>
    <p:cSldViewPr>
      <p:cViewPr varScale="1">
        <p:scale>
          <a:sx n="65" d="100"/>
          <a:sy n="65" d="100"/>
        </p:scale>
        <p:origin x="648" y="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2057341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D8990-CBC9-A0D6-D78F-8E570840CD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14525" y="1484013"/>
            <a:ext cx="11487150" cy="3156938"/>
          </a:xfrm>
        </p:spPr>
        <p:txBody>
          <a:bodyPr anchor="b"/>
          <a:lstStyle>
            <a:lvl1pPr algn="ctr">
              <a:defRPr sz="753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F0ECB3-503A-1BA8-1AB3-DCBFD21A06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14525" y="4762695"/>
            <a:ext cx="11487150" cy="2189285"/>
          </a:xfrm>
        </p:spPr>
        <p:txBody>
          <a:bodyPr/>
          <a:lstStyle>
            <a:lvl1pPr marL="0" indent="0" algn="ctr">
              <a:buNone/>
              <a:defRPr sz="3015"/>
            </a:lvl1pPr>
            <a:lvl2pPr marL="574380" indent="0" algn="ctr">
              <a:buNone/>
              <a:defRPr sz="2513"/>
            </a:lvl2pPr>
            <a:lvl3pPr marL="1148761" indent="0" algn="ctr">
              <a:buNone/>
              <a:defRPr sz="2261"/>
            </a:lvl3pPr>
            <a:lvl4pPr marL="1723141" indent="0" algn="ctr">
              <a:buNone/>
              <a:defRPr sz="2010"/>
            </a:lvl4pPr>
            <a:lvl5pPr marL="2297521" indent="0" algn="ctr">
              <a:buNone/>
              <a:defRPr sz="2010"/>
            </a:lvl5pPr>
            <a:lvl6pPr marL="2871902" indent="0" algn="ctr">
              <a:buNone/>
              <a:defRPr sz="2010"/>
            </a:lvl6pPr>
            <a:lvl7pPr marL="3446282" indent="0" algn="ctr">
              <a:buNone/>
              <a:defRPr sz="2010"/>
            </a:lvl7pPr>
            <a:lvl8pPr marL="4020663" indent="0" algn="ctr">
              <a:buNone/>
              <a:defRPr sz="2010"/>
            </a:lvl8pPr>
            <a:lvl9pPr marL="4595043" indent="0" algn="ctr">
              <a:buNone/>
              <a:defRPr sz="201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FD9FAF-FE3F-59E7-8F00-DC6929FA1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CB3D8-6487-9414-06A7-E8970AD0E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22219E-6613-E324-CDF7-B6060BD38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761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340011-3F29-1CD8-AF16-585FDBD3B3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5F14AC-5897-7821-9DE7-B0D621AC11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2F8608-5E7B-9506-512F-FBB2B5176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CD1DE2-9F3A-CB84-774F-6B26A5B9D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A32159-921E-29C1-D370-2651BEAE6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552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AFA832-5EF5-C7DB-83AF-AD09A82048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0960655" y="482777"/>
            <a:ext cx="3302556" cy="76845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A5776B-575C-F22F-66A5-BE6D105DD1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52989" y="482777"/>
            <a:ext cx="9716214" cy="76845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AF21D-961C-ED42-C8DD-5117AD5CF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B8770-E5F8-3240-8041-57D2480B9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D98061-A6B8-0615-B042-1680D782F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87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75728-7922-FFDD-55FD-7641B970A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FA789C-7B09-0571-F957-934EC0F085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0DF766-8092-6F65-D5E9-7FEAFEEDD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DB5275-F21A-A77E-B139-4D694AE92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D6C3AA-6A82-1AFC-C7B0-0FB3499F3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63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1145A-1D18-E516-C34B-9C7D1A7728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45011" y="2260654"/>
            <a:ext cx="13210223" cy="3771952"/>
          </a:xfrm>
        </p:spPr>
        <p:txBody>
          <a:bodyPr anchor="b"/>
          <a:lstStyle>
            <a:lvl1pPr>
              <a:defRPr sz="753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9F7BD9-D474-322D-3DEB-78396D004F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45011" y="6068290"/>
            <a:ext cx="13210223" cy="1983581"/>
          </a:xfrm>
        </p:spPr>
        <p:txBody>
          <a:bodyPr/>
          <a:lstStyle>
            <a:lvl1pPr marL="0" indent="0">
              <a:buNone/>
              <a:defRPr sz="3015">
                <a:solidFill>
                  <a:schemeClr val="tx1">
                    <a:tint val="75000"/>
                  </a:schemeClr>
                </a:solidFill>
              </a:defRPr>
            </a:lvl1pPr>
            <a:lvl2pPr marL="574380" indent="0">
              <a:buNone/>
              <a:defRPr sz="2513">
                <a:solidFill>
                  <a:schemeClr val="tx1">
                    <a:tint val="75000"/>
                  </a:schemeClr>
                </a:solidFill>
              </a:defRPr>
            </a:lvl2pPr>
            <a:lvl3pPr marL="1148761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3pPr>
            <a:lvl4pPr marL="1723141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4pPr>
            <a:lvl5pPr marL="2297521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5pPr>
            <a:lvl6pPr marL="2871902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6pPr>
            <a:lvl7pPr marL="3446282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7pPr>
            <a:lvl8pPr marL="4020663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8pPr>
            <a:lvl9pPr marL="4595043" indent="0">
              <a:buNone/>
              <a:defRPr sz="20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1F4148-180B-A9E4-1B0A-9B2D018C8D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2F9E51-464D-36B0-6A68-1A848EF3E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6E8CED-A25E-DBA1-5E15-523D733BC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843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7F5C5-A973-AB72-F3CA-A06CDAA817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A3E815-59AC-E373-7EF9-75ABCB1856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52989" y="2413882"/>
            <a:ext cx="6509385" cy="57534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6DC76C-57CF-A70B-9E08-E624D76DFF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753826" y="2413882"/>
            <a:ext cx="6509385" cy="575343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7ABB08-684B-3F28-970E-19C667928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4A018B-661D-BC80-6AA0-E3005BCB8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89D78A-2CDB-B62F-235E-2DDEA3849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301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21F49-862E-7337-2476-9598CBA922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4983" y="482777"/>
            <a:ext cx="13210223" cy="175268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049A8A-63E6-DF20-561F-8E0D987320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54984" y="2222871"/>
            <a:ext cx="6479470" cy="1089395"/>
          </a:xfrm>
        </p:spPr>
        <p:txBody>
          <a:bodyPr anchor="b"/>
          <a:lstStyle>
            <a:lvl1pPr marL="0" indent="0">
              <a:buNone/>
              <a:defRPr sz="3015" b="1"/>
            </a:lvl1pPr>
            <a:lvl2pPr marL="574380" indent="0">
              <a:buNone/>
              <a:defRPr sz="2513" b="1"/>
            </a:lvl2pPr>
            <a:lvl3pPr marL="1148761" indent="0">
              <a:buNone/>
              <a:defRPr sz="2261" b="1"/>
            </a:lvl3pPr>
            <a:lvl4pPr marL="1723141" indent="0">
              <a:buNone/>
              <a:defRPr sz="2010" b="1"/>
            </a:lvl4pPr>
            <a:lvl5pPr marL="2297521" indent="0">
              <a:buNone/>
              <a:defRPr sz="2010" b="1"/>
            </a:lvl5pPr>
            <a:lvl6pPr marL="2871902" indent="0">
              <a:buNone/>
              <a:defRPr sz="2010" b="1"/>
            </a:lvl6pPr>
            <a:lvl7pPr marL="3446282" indent="0">
              <a:buNone/>
              <a:defRPr sz="2010" b="1"/>
            </a:lvl7pPr>
            <a:lvl8pPr marL="4020663" indent="0">
              <a:buNone/>
              <a:defRPr sz="2010" b="1"/>
            </a:lvl8pPr>
            <a:lvl9pPr marL="4595043" indent="0">
              <a:buNone/>
              <a:defRPr sz="201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B91B00-2550-0A18-678B-8B0BEA3802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54984" y="3312266"/>
            <a:ext cx="6479470" cy="48718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567C46-9E36-9BAA-3183-34137F6498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753826" y="2222871"/>
            <a:ext cx="6511380" cy="1089395"/>
          </a:xfrm>
        </p:spPr>
        <p:txBody>
          <a:bodyPr anchor="b"/>
          <a:lstStyle>
            <a:lvl1pPr marL="0" indent="0">
              <a:buNone/>
              <a:defRPr sz="3015" b="1"/>
            </a:lvl1pPr>
            <a:lvl2pPr marL="574380" indent="0">
              <a:buNone/>
              <a:defRPr sz="2513" b="1"/>
            </a:lvl2pPr>
            <a:lvl3pPr marL="1148761" indent="0">
              <a:buNone/>
              <a:defRPr sz="2261" b="1"/>
            </a:lvl3pPr>
            <a:lvl4pPr marL="1723141" indent="0">
              <a:buNone/>
              <a:defRPr sz="2010" b="1"/>
            </a:lvl4pPr>
            <a:lvl5pPr marL="2297521" indent="0">
              <a:buNone/>
              <a:defRPr sz="2010" b="1"/>
            </a:lvl5pPr>
            <a:lvl6pPr marL="2871902" indent="0">
              <a:buNone/>
              <a:defRPr sz="2010" b="1"/>
            </a:lvl6pPr>
            <a:lvl7pPr marL="3446282" indent="0">
              <a:buNone/>
              <a:defRPr sz="2010" b="1"/>
            </a:lvl7pPr>
            <a:lvl8pPr marL="4020663" indent="0">
              <a:buNone/>
              <a:defRPr sz="2010" b="1"/>
            </a:lvl8pPr>
            <a:lvl9pPr marL="4595043" indent="0">
              <a:buNone/>
              <a:defRPr sz="201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2D6655-E2CA-6604-4DE3-BE28F399B35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753826" y="3312266"/>
            <a:ext cx="6511380" cy="48718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6A8D7E-E737-9912-25E3-63B263D79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FB19D91-FF9D-D946-1CEB-1347B6FEC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FC410C-3FDD-36D6-8969-A8A101AA3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396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6C23C-82FF-B5A0-AA4F-D95DF940C0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EDC7FF-1569-1DA6-1FCC-27BE966B2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6FA82C-519A-5647-450F-9CF428031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BEF583F-F41C-2364-895A-D1EAD4E57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730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358234-E9BC-35D4-36A0-0D37FB671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AF3CA0-FDB2-48B8-1055-5603B99EE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F8C5F3-ABAB-FFD2-153A-2AA19D6116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43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9BAB62-A63E-2817-9EE8-AA5EFFBE5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4984" y="604520"/>
            <a:ext cx="4939873" cy="2115820"/>
          </a:xfrm>
        </p:spPr>
        <p:txBody>
          <a:bodyPr anchor="b"/>
          <a:lstStyle>
            <a:lvl1pPr>
              <a:defRPr sz="40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103C5B-C9B1-A89D-4DD5-3779354E97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511380" y="1305596"/>
            <a:ext cx="7753826" cy="6444015"/>
          </a:xfrm>
        </p:spPr>
        <p:txBody>
          <a:bodyPr/>
          <a:lstStyle>
            <a:lvl1pPr>
              <a:defRPr sz="4020"/>
            </a:lvl1pPr>
            <a:lvl2pPr>
              <a:defRPr sz="3518"/>
            </a:lvl2pPr>
            <a:lvl3pPr>
              <a:defRPr sz="3015"/>
            </a:lvl3pPr>
            <a:lvl4pPr>
              <a:defRPr sz="2513"/>
            </a:lvl4pPr>
            <a:lvl5pPr>
              <a:defRPr sz="2513"/>
            </a:lvl5pPr>
            <a:lvl6pPr>
              <a:defRPr sz="2513"/>
            </a:lvl6pPr>
            <a:lvl7pPr>
              <a:defRPr sz="2513"/>
            </a:lvl7pPr>
            <a:lvl8pPr>
              <a:defRPr sz="2513"/>
            </a:lvl8pPr>
            <a:lvl9pPr>
              <a:defRPr sz="251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CD11DD-C6E0-56B1-7ABB-403D4F25A9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54984" y="2720340"/>
            <a:ext cx="4939873" cy="5039766"/>
          </a:xfrm>
        </p:spPr>
        <p:txBody>
          <a:bodyPr/>
          <a:lstStyle>
            <a:lvl1pPr marL="0" indent="0">
              <a:buNone/>
              <a:defRPr sz="2010"/>
            </a:lvl1pPr>
            <a:lvl2pPr marL="574380" indent="0">
              <a:buNone/>
              <a:defRPr sz="1759"/>
            </a:lvl2pPr>
            <a:lvl3pPr marL="1148761" indent="0">
              <a:buNone/>
              <a:defRPr sz="1508"/>
            </a:lvl3pPr>
            <a:lvl4pPr marL="1723141" indent="0">
              <a:buNone/>
              <a:defRPr sz="1256"/>
            </a:lvl4pPr>
            <a:lvl5pPr marL="2297521" indent="0">
              <a:buNone/>
              <a:defRPr sz="1256"/>
            </a:lvl5pPr>
            <a:lvl6pPr marL="2871902" indent="0">
              <a:buNone/>
              <a:defRPr sz="1256"/>
            </a:lvl6pPr>
            <a:lvl7pPr marL="3446282" indent="0">
              <a:buNone/>
              <a:defRPr sz="1256"/>
            </a:lvl7pPr>
            <a:lvl8pPr marL="4020663" indent="0">
              <a:buNone/>
              <a:defRPr sz="1256"/>
            </a:lvl8pPr>
            <a:lvl9pPr marL="4595043" indent="0">
              <a:buNone/>
              <a:defRPr sz="125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99F96A-A8BF-5054-F433-8F1E5B89A2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C3982-0D99-516C-4D24-45D605B578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6C979F-FC90-6D97-F016-8123B0A1C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67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0453F4-D5E2-FBE6-D588-D286E8C246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4984" y="604520"/>
            <a:ext cx="4939873" cy="2115820"/>
          </a:xfrm>
        </p:spPr>
        <p:txBody>
          <a:bodyPr anchor="b"/>
          <a:lstStyle>
            <a:lvl1pPr>
              <a:defRPr sz="40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3A1A369-B745-D00A-CA5F-FE7438E90F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511380" y="1305596"/>
            <a:ext cx="7753826" cy="6444015"/>
          </a:xfrm>
        </p:spPr>
        <p:txBody>
          <a:bodyPr/>
          <a:lstStyle>
            <a:lvl1pPr marL="0" indent="0">
              <a:buNone/>
              <a:defRPr sz="4020"/>
            </a:lvl1pPr>
            <a:lvl2pPr marL="574380" indent="0">
              <a:buNone/>
              <a:defRPr sz="3518"/>
            </a:lvl2pPr>
            <a:lvl3pPr marL="1148761" indent="0">
              <a:buNone/>
              <a:defRPr sz="3015"/>
            </a:lvl3pPr>
            <a:lvl4pPr marL="1723141" indent="0">
              <a:buNone/>
              <a:defRPr sz="2513"/>
            </a:lvl4pPr>
            <a:lvl5pPr marL="2297521" indent="0">
              <a:buNone/>
              <a:defRPr sz="2513"/>
            </a:lvl5pPr>
            <a:lvl6pPr marL="2871902" indent="0">
              <a:buNone/>
              <a:defRPr sz="2513"/>
            </a:lvl6pPr>
            <a:lvl7pPr marL="3446282" indent="0">
              <a:buNone/>
              <a:defRPr sz="2513"/>
            </a:lvl7pPr>
            <a:lvl8pPr marL="4020663" indent="0">
              <a:buNone/>
              <a:defRPr sz="2513"/>
            </a:lvl8pPr>
            <a:lvl9pPr marL="4595043" indent="0">
              <a:buNone/>
              <a:defRPr sz="2513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22F3F63-3D11-889C-E3E3-4BF08F2468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54984" y="2720340"/>
            <a:ext cx="4939873" cy="5039766"/>
          </a:xfrm>
        </p:spPr>
        <p:txBody>
          <a:bodyPr/>
          <a:lstStyle>
            <a:lvl1pPr marL="0" indent="0">
              <a:buNone/>
              <a:defRPr sz="2010"/>
            </a:lvl1pPr>
            <a:lvl2pPr marL="574380" indent="0">
              <a:buNone/>
              <a:defRPr sz="1759"/>
            </a:lvl2pPr>
            <a:lvl3pPr marL="1148761" indent="0">
              <a:buNone/>
              <a:defRPr sz="1508"/>
            </a:lvl3pPr>
            <a:lvl4pPr marL="1723141" indent="0">
              <a:buNone/>
              <a:defRPr sz="1256"/>
            </a:lvl4pPr>
            <a:lvl5pPr marL="2297521" indent="0">
              <a:buNone/>
              <a:defRPr sz="1256"/>
            </a:lvl5pPr>
            <a:lvl6pPr marL="2871902" indent="0">
              <a:buNone/>
              <a:defRPr sz="1256"/>
            </a:lvl6pPr>
            <a:lvl7pPr marL="3446282" indent="0">
              <a:buNone/>
              <a:defRPr sz="1256"/>
            </a:lvl7pPr>
            <a:lvl8pPr marL="4020663" indent="0">
              <a:buNone/>
              <a:defRPr sz="1256"/>
            </a:lvl8pPr>
            <a:lvl9pPr marL="4595043" indent="0">
              <a:buNone/>
              <a:defRPr sz="125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2396F4-B0E4-46E6-E021-38C4BB4D17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695645-A909-182F-C3DB-CF74922E2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8B8FB9-EE1A-584D-ACA1-059B3B25A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090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3F21FFD-7E01-9EF3-B273-7E2BA76D10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52989" y="482777"/>
            <a:ext cx="13210223" cy="1752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59582B-269C-356D-D1DF-472E6FC004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52989" y="2413882"/>
            <a:ext cx="13210223" cy="57534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F2107-45DB-0925-9579-283F85E7D7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52989" y="8404508"/>
            <a:ext cx="3446145" cy="4827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581544-7E6C-8F4D-9648-8D0571A0E28D}" type="datetimeFigureOut">
              <a:rPr lang="en-US" smtClean="0"/>
              <a:t>20-Feb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74301-5436-6963-1206-DD522BE1A6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073491" y="8404508"/>
            <a:ext cx="5169218" cy="4827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09A299-634F-F053-7FAC-B69BFC237C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817066" y="8404508"/>
            <a:ext cx="3446145" cy="48277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26B8D-2924-694F-B0CB-57DB11E5C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571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7" r:id="rId1"/>
    <p:sldLayoutId id="2147483668" r:id="rId2"/>
    <p:sldLayoutId id="2147483669" r:id="rId3"/>
    <p:sldLayoutId id="2147483670" r:id="rId4"/>
    <p:sldLayoutId id="2147483671" r:id="rId5"/>
    <p:sldLayoutId id="2147483672" r:id="rId6"/>
    <p:sldLayoutId id="2147483673" r:id="rId7"/>
    <p:sldLayoutId id="2147483674" r:id="rId8"/>
    <p:sldLayoutId id="2147483675" r:id="rId9"/>
    <p:sldLayoutId id="2147483676" r:id="rId10"/>
    <p:sldLayoutId id="2147483677" r:id="rId11"/>
  </p:sldLayoutIdLst>
  <p:txStyles>
    <p:titleStyle>
      <a:lvl1pPr algn="l" defTabSz="1148761" rtl="0" eaLnBrk="1" latinLnBrk="0" hangingPunct="1">
        <a:lnSpc>
          <a:spcPct val="90000"/>
        </a:lnSpc>
        <a:spcBef>
          <a:spcPct val="0"/>
        </a:spcBef>
        <a:buNone/>
        <a:defRPr sz="55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7190" indent="-287190" algn="l" defTabSz="1148761" rtl="0" eaLnBrk="1" latinLnBrk="0" hangingPunct="1">
        <a:lnSpc>
          <a:spcPct val="90000"/>
        </a:lnSpc>
        <a:spcBef>
          <a:spcPts val="1256"/>
        </a:spcBef>
        <a:buFont typeface="Arial" panose="020B0604020202020204" pitchFamily="34" charset="0"/>
        <a:buChar char="•"/>
        <a:defRPr sz="3518" kern="1200">
          <a:solidFill>
            <a:schemeClr val="tx1"/>
          </a:solidFill>
          <a:latin typeface="+mn-lt"/>
          <a:ea typeface="+mn-ea"/>
          <a:cs typeface="+mn-cs"/>
        </a:defRPr>
      </a:lvl1pPr>
      <a:lvl2pPr marL="861571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3015" kern="1200">
          <a:solidFill>
            <a:schemeClr val="tx1"/>
          </a:solidFill>
          <a:latin typeface="+mn-lt"/>
          <a:ea typeface="+mn-ea"/>
          <a:cs typeface="+mn-cs"/>
        </a:defRPr>
      </a:lvl2pPr>
      <a:lvl3pPr marL="1435951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513" kern="1200">
          <a:solidFill>
            <a:schemeClr val="tx1"/>
          </a:solidFill>
          <a:latin typeface="+mn-lt"/>
          <a:ea typeface="+mn-ea"/>
          <a:cs typeface="+mn-cs"/>
        </a:defRPr>
      </a:lvl3pPr>
      <a:lvl4pPr marL="2010331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4pPr>
      <a:lvl5pPr marL="2584712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5pPr>
      <a:lvl6pPr marL="3159092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6pPr>
      <a:lvl7pPr marL="3733472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7pPr>
      <a:lvl8pPr marL="4307853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8pPr>
      <a:lvl9pPr marL="4882233" indent="-287190" algn="l" defTabSz="1148761" rtl="0" eaLnBrk="1" latinLnBrk="0" hangingPunct="1">
        <a:lnSpc>
          <a:spcPct val="90000"/>
        </a:lnSpc>
        <a:spcBef>
          <a:spcPts val="628"/>
        </a:spcBef>
        <a:buFont typeface="Arial" panose="020B0604020202020204" pitchFamily="34" charset="0"/>
        <a:buChar char="•"/>
        <a:defRPr sz="22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1pPr>
      <a:lvl2pPr marL="574380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2pPr>
      <a:lvl3pPr marL="1148761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3pPr>
      <a:lvl4pPr marL="1723141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4pPr>
      <a:lvl5pPr marL="2297521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5pPr>
      <a:lvl6pPr marL="2871902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6pPr>
      <a:lvl7pPr marL="3446282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7pPr>
      <a:lvl8pPr marL="4020663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8pPr>
      <a:lvl9pPr marL="4595043" algn="l" defTabSz="1148761" rtl="0" eaLnBrk="1" latinLnBrk="0" hangingPunct="1">
        <a:defRPr sz="22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A7BA093-333F-20A3-6E03-F1B80FB30FD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205" t="4497" r="29982"/>
          <a:stretch/>
        </p:blipFill>
        <p:spPr>
          <a:xfrm>
            <a:off x="5819271" y="226219"/>
            <a:ext cx="2994148" cy="86434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B3255D3-1905-FEF3-62E3-A0635757131F}"/>
              </a:ext>
            </a:extLst>
          </p:cNvPr>
          <p:cNvSpPr txBox="1"/>
          <p:nvPr/>
        </p:nvSpPr>
        <p:spPr>
          <a:xfrm>
            <a:off x="969228" y="728782"/>
            <a:ext cx="2593980" cy="4402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148761"/>
            <a:r>
              <a:rPr lang="en-US" sz="2261" dirty="0">
                <a:solidFill>
                  <a:prstClr val="black"/>
                </a:solidFill>
                <a:latin typeface="Calibri" panose="020F0502020204030204"/>
              </a:rPr>
              <a:t>Supplementary Fig 1</a:t>
            </a:r>
          </a:p>
        </p:txBody>
      </p:sp>
      <p:sp>
        <p:nvSpPr>
          <p:cNvPr id="4" name="Rectangle 3"/>
          <p:cNvSpPr/>
          <p:nvPr/>
        </p:nvSpPr>
        <p:spPr>
          <a:xfrm>
            <a:off x="8033109" y="5504781"/>
            <a:ext cx="7658100" cy="556306"/>
          </a:xfrm>
          <a:prstGeom prst="rect">
            <a:avLst/>
          </a:prstGeom>
        </p:spPr>
        <p:txBody>
          <a:bodyPr>
            <a:spAutoFit/>
          </a:bodyPr>
          <a:lstStyle/>
          <a:p>
            <a:pPr defTabSz="1148761"/>
            <a:r>
              <a:rPr lang="en-US" sz="1005" dirty="0" err="1">
                <a:solidFill>
                  <a:prstClr val="black"/>
                </a:solidFill>
                <a:latin typeface="AdvOT3b30f6db.B"/>
              </a:rPr>
              <a:t>Suppl</a:t>
            </a:r>
            <a:r>
              <a:rPr lang="en-US" sz="1005" dirty="0">
                <a:solidFill>
                  <a:prstClr val="black"/>
                </a:solidFill>
                <a:latin typeface="AdvOT3b30f6db.B"/>
              </a:rPr>
              <a:t> 1:  </a:t>
            </a:r>
            <a:r>
              <a:rPr lang="en-US" sz="1005" dirty="0" err="1">
                <a:solidFill>
                  <a:prstClr val="black"/>
                </a:solidFill>
                <a:latin typeface="AdvTT6780a46b"/>
              </a:rPr>
              <a:t>Heatmap</a:t>
            </a:r>
            <a:r>
              <a:rPr lang="en-US" sz="1005" dirty="0">
                <a:solidFill>
                  <a:prstClr val="black"/>
                </a:solidFill>
                <a:latin typeface="AdvTT6780a46b"/>
              </a:rPr>
              <a:t> representing Cluster 4 genes, from the k-means clustering (</a:t>
            </a:r>
            <a:r>
              <a:rPr lang="en-US" sz="1005" dirty="0">
                <a:solidFill>
                  <a:prstClr val="black"/>
                </a:solidFill>
                <a:latin typeface="AdvOT65f8a23b.I"/>
              </a:rPr>
              <a:t>k </a:t>
            </a:r>
            <a:r>
              <a:rPr lang="en-US" sz="1005" dirty="0">
                <a:solidFill>
                  <a:prstClr val="black"/>
                </a:solidFill>
                <a:latin typeface="AdvTTab7e17fd"/>
              </a:rPr>
              <a:t>= </a:t>
            </a:r>
            <a:r>
              <a:rPr lang="en-US" sz="1005" dirty="0">
                <a:solidFill>
                  <a:prstClr val="black"/>
                </a:solidFill>
                <a:latin typeface="AdvTT6780a46b"/>
              </a:rPr>
              <a:t>9) of normalized counts per</a:t>
            </a:r>
          </a:p>
          <a:p>
            <a:pPr defTabSz="1148761"/>
            <a:r>
              <a:rPr lang="en-US" sz="1005" dirty="0">
                <a:solidFill>
                  <a:prstClr val="black"/>
                </a:solidFill>
                <a:latin typeface="AdvTT6780a46b"/>
              </a:rPr>
              <a:t>million (CPM) for signi</a:t>
            </a:r>
            <a:r>
              <a:rPr lang="en-US" sz="1005" dirty="0">
                <a:solidFill>
                  <a:prstClr val="black"/>
                </a:solidFill>
                <a:latin typeface="AdvTT6780a46b+fb"/>
              </a:rPr>
              <a:t>fi</a:t>
            </a:r>
            <a:r>
              <a:rPr lang="en-US" sz="1005" dirty="0">
                <a:solidFill>
                  <a:prstClr val="black"/>
                </a:solidFill>
                <a:latin typeface="AdvTT6780a46b"/>
              </a:rPr>
              <a:t>cantly affected genes in the multi-group analysis (FDR &lt; 0.05) on the data set containing all samples</a:t>
            </a:r>
          </a:p>
          <a:p>
            <a:pPr defTabSz="1148761"/>
            <a:r>
              <a:rPr lang="en-US" sz="1005" dirty="0">
                <a:solidFill>
                  <a:prstClr val="black"/>
                </a:solidFill>
                <a:latin typeface="AdvTT6780a46b"/>
              </a:rPr>
              <a:t> (</a:t>
            </a:r>
            <a:r>
              <a:rPr lang="en-US" sz="1005" dirty="0">
                <a:solidFill>
                  <a:prstClr val="black"/>
                </a:solidFill>
                <a:latin typeface="AdvOT65f8a23b.I"/>
              </a:rPr>
              <a:t>n </a:t>
            </a:r>
            <a:r>
              <a:rPr lang="en-US" sz="1005" dirty="0">
                <a:solidFill>
                  <a:prstClr val="black"/>
                </a:solidFill>
                <a:latin typeface="AdvTTab7e17fd"/>
              </a:rPr>
              <a:t>= </a:t>
            </a:r>
            <a:r>
              <a:rPr lang="en-US" sz="1005" dirty="0">
                <a:solidFill>
                  <a:prstClr val="black"/>
                </a:solidFill>
                <a:latin typeface="AdvTT6780a46b"/>
              </a:rPr>
              <a:t>2/group). Samples are numbered based on technical repeats (two of each)</a:t>
            </a:r>
            <a:endParaRPr lang="en-US" sz="2261" dirty="0">
              <a:solidFill>
                <a:prstClr val="black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68976146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Words>69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AdvOT3b30f6db.B</vt:lpstr>
      <vt:lpstr>AdvOT65f8a23b.I</vt:lpstr>
      <vt:lpstr>AdvTT6780a46b</vt:lpstr>
      <vt:lpstr>AdvTT6780a46b+fb</vt:lpstr>
      <vt:lpstr>AdvTTab7e17fd</vt:lpstr>
      <vt:lpstr>Arial</vt:lpstr>
      <vt:lpstr>Calibri</vt:lpstr>
      <vt:lpstr>Calibri Light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Rajesh Nakoti</cp:lastModifiedBy>
  <cp:revision>5</cp:revision>
  <dcterms:created xsi:type="dcterms:W3CDTF">2023-02-06T11:18:13Z</dcterms:created>
  <dcterms:modified xsi:type="dcterms:W3CDTF">2023-02-20T04:19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3-02-06T00:00:00Z</vt:filetime>
  </property>
</Properties>
</file>